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82B61-3F6F-4612-AAC6-4B649A552B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A0FE4F-4FF8-4E1D-8BAF-BE83753B79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0DC9B-4471-40CD-B2AF-CCCCD5A36C0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56B8B0-4658-4CEC-97F0-64F9D1C1EB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96B5AA-5C98-434F-8685-85FC383373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2F9BD2-E8F7-48AB-9AA0-2DF0B85A90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84152D-7842-4AD4-A05D-7D5DC3A653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557E40-0173-4DD2-808E-D5C717306D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1823B3-B12B-47C4-96DE-B3D6AABA3D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B2EF70-834B-4A78-AE52-522342AAAD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68A46-DDDA-4A07-AC76-9A1D9CC067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69D88-A918-43A3-B730-EAF3EACB22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C606D6-0097-4B3F-8C35-70C20765996B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"/>
          <p:cNvGrpSpPr/>
          <p:nvPr/>
        </p:nvGrpSpPr>
        <p:grpSpPr>
          <a:xfrm>
            <a:off x="1676520" y="-271440"/>
            <a:ext cx="5472000" cy="4537080"/>
            <a:chOff x="1676520" y="-271440"/>
            <a:chExt cx="5472000" cy="4537080"/>
          </a:xfrm>
        </p:grpSpPr>
        <p:sp>
          <p:nvSpPr>
            <p:cNvPr id="42" name="AutoShape 5"/>
            <p:cNvSpPr/>
            <p:nvPr/>
          </p:nvSpPr>
          <p:spPr>
            <a:xfrm>
              <a:off x="1676520" y="-271440"/>
              <a:ext cx="5472000" cy="453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_s2057"/>
            <p:cNvSpPr/>
            <p:nvPr/>
          </p:nvSpPr>
          <p:spPr>
            <a:xfrm>
              <a:off x="4208400" y="1146240"/>
              <a:ext cx="1701720" cy="1701720"/>
            </a:xfrm>
            <a:prstGeom prst="ellipse">
              <a:avLst/>
            </a:prstGeom>
            <a:solidFill>
              <a:srgbClr val="ff7c80">
                <a:alpha val="50000"/>
              </a:srgbClr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_s2058"/>
            <p:cNvSpPr/>
            <p:nvPr/>
          </p:nvSpPr>
          <p:spPr>
            <a:xfrm>
              <a:off x="6080040" y="1784520"/>
              <a:ext cx="895320" cy="42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_s2059"/>
            <p:cNvSpPr/>
            <p:nvPr/>
          </p:nvSpPr>
          <p:spPr>
            <a:xfrm>
              <a:off x="3260880" y="1168560"/>
              <a:ext cx="1701720" cy="1701720"/>
            </a:xfrm>
            <a:prstGeom prst="ellipse">
              <a:avLst/>
            </a:prstGeom>
            <a:solidFill>
              <a:srgbClr val="6699ff">
                <a:alpha val="50000"/>
              </a:srgbClr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_s2060"/>
            <p:cNvSpPr/>
            <p:nvPr/>
          </p:nvSpPr>
          <p:spPr>
            <a:xfrm>
              <a:off x="1846080" y="1784520"/>
              <a:ext cx="895680" cy="42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3"/>
            <p:cNvSpPr/>
            <p:nvPr/>
          </p:nvSpPr>
          <p:spPr>
            <a:xfrm>
              <a:off x="3603600" y="1751040"/>
              <a:ext cx="412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9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4"/>
            <p:cNvSpPr/>
            <p:nvPr/>
          </p:nvSpPr>
          <p:spPr>
            <a:xfrm>
              <a:off x="4356360" y="1751040"/>
              <a:ext cx="412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4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9" name="_s1028"/>
          <p:cNvSpPr/>
          <p:nvPr/>
        </p:nvSpPr>
        <p:spPr>
          <a:xfrm>
            <a:off x="1252440" y="2347920"/>
            <a:ext cx="1701720" cy="1701720"/>
          </a:xfrm>
          <a:prstGeom prst="ellipse">
            <a:avLst/>
          </a:prstGeom>
          <a:solidFill>
            <a:srgbClr val="000080">
              <a:alpha val="50000"/>
            </a:srgbClr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_s1030"/>
          <p:cNvSpPr/>
          <p:nvPr/>
        </p:nvSpPr>
        <p:spPr>
          <a:xfrm>
            <a:off x="304920" y="2370240"/>
            <a:ext cx="1701720" cy="1701720"/>
          </a:xfrm>
          <a:prstGeom prst="ellipse">
            <a:avLst/>
          </a:prstGeom>
          <a:solidFill>
            <a:srgbClr val="ccecff">
              <a:alpha val="50000"/>
            </a:srgbClr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7"/>
          <p:cNvSpPr/>
          <p:nvPr/>
        </p:nvSpPr>
        <p:spPr>
          <a:xfrm>
            <a:off x="595440" y="301932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7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8"/>
          <p:cNvSpPr/>
          <p:nvPr/>
        </p:nvSpPr>
        <p:spPr>
          <a:xfrm>
            <a:off x="1464480" y="299880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9"/>
          <p:cNvSpPr/>
          <p:nvPr/>
        </p:nvSpPr>
        <p:spPr>
          <a:xfrm>
            <a:off x="2179800" y="299232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5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_s1028"/>
          <p:cNvSpPr/>
          <p:nvPr/>
        </p:nvSpPr>
        <p:spPr>
          <a:xfrm>
            <a:off x="7061040" y="2340000"/>
            <a:ext cx="1702080" cy="1701720"/>
          </a:xfrm>
          <a:prstGeom prst="ellipse">
            <a:avLst/>
          </a:prstGeom>
          <a:solidFill>
            <a:srgbClr val="cc0000">
              <a:alpha val="50000"/>
            </a:srgbClr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_s1030"/>
          <p:cNvSpPr/>
          <p:nvPr/>
        </p:nvSpPr>
        <p:spPr>
          <a:xfrm>
            <a:off x="6113520" y="2362320"/>
            <a:ext cx="1701720" cy="1701720"/>
          </a:xfrm>
          <a:prstGeom prst="ellipse">
            <a:avLst/>
          </a:prstGeom>
          <a:solidFill>
            <a:srgbClr val="ffcccc">
              <a:alpha val="50000"/>
            </a:srgbClr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2"/>
          <p:cNvSpPr/>
          <p:nvPr/>
        </p:nvSpPr>
        <p:spPr>
          <a:xfrm>
            <a:off x="6404040" y="303048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3"/>
          <p:cNvSpPr/>
          <p:nvPr/>
        </p:nvSpPr>
        <p:spPr>
          <a:xfrm>
            <a:off x="7167600" y="3030480"/>
            <a:ext cx="571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4"/>
          <p:cNvSpPr/>
          <p:nvPr/>
        </p:nvSpPr>
        <p:spPr>
          <a:xfrm>
            <a:off x="7989840" y="300348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4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5"/>
          <p:cNvSpPr/>
          <p:nvPr/>
        </p:nvSpPr>
        <p:spPr>
          <a:xfrm>
            <a:off x="5051520" y="172404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ZoneTexte 24"/>
          <p:cNvSpPr/>
          <p:nvPr/>
        </p:nvSpPr>
        <p:spPr>
          <a:xfrm>
            <a:off x="609480" y="4564080"/>
            <a:ext cx="914400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owess and global normalization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T-Test p&lt;0,05 with a treshold 2x fold change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ZoneTexte 26"/>
          <p:cNvSpPr/>
          <p:nvPr/>
        </p:nvSpPr>
        <p:spPr>
          <a:xfrm>
            <a:off x="2646720" y="94788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old Shoc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ZoneTexte 27"/>
          <p:cNvSpPr/>
          <p:nvPr/>
        </p:nvSpPr>
        <p:spPr>
          <a:xfrm>
            <a:off x="5831280" y="947880"/>
            <a:ext cx="122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Heat Shoc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ZoneTexte 28"/>
          <p:cNvSpPr/>
          <p:nvPr/>
        </p:nvSpPr>
        <p:spPr>
          <a:xfrm>
            <a:off x="8210160" y="2044800"/>
            <a:ext cx="659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HS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ZoneTexte 29"/>
          <p:cNvSpPr/>
          <p:nvPr/>
        </p:nvSpPr>
        <p:spPr>
          <a:xfrm>
            <a:off x="6100560" y="3967200"/>
            <a:ext cx="65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H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ZoneTexte 30"/>
          <p:cNvSpPr/>
          <p:nvPr/>
        </p:nvSpPr>
        <p:spPr>
          <a:xfrm>
            <a:off x="347040" y="2062080"/>
            <a:ext cx="6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S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ZoneTexte 31"/>
          <p:cNvSpPr/>
          <p:nvPr/>
        </p:nvSpPr>
        <p:spPr>
          <a:xfrm>
            <a:off x="2289960" y="3967200"/>
            <a:ext cx="6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S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ZoneTexte 30"/>
          <p:cNvSpPr/>
          <p:nvPr/>
        </p:nvSpPr>
        <p:spPr>
          <a:xfrm>
            <a:off x="2743200" y="5954760"/>
            <a:ext cx="3624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30T12:28:04Z</dcterms:created>
  <dc:creator>quentin</dc:creator>
  <dc:description/>
  <dc:language>en-US</dc:language>
  <cp:lastModifiedBy>quentin</cp:lastModifiedBy>
  <dcterms:modified xsi:type="dcterms:W3CDTF">2010-09-30T12:28:10Z</dcterms:modified>
  <cp:revision>1</cp:revision>
  <dc:subject/>
  <dc:title>Diapositive 1</dc:title>
</cp:coreProperties>
</file>